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500" r:id="rId2"/>
    <p:sldId id="505" r:id="rId3"/>
    <p:sldId id="506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D2694319-82BD-4D14-88B9-2F36646D8A15}"/>
    <pc:docChg chg="undo custSel addSld delSld modSld">
      <pc:chgData name="Mohan, Man" userId="37104710-05df-4370-9d86-514a293a6e2e" providerId="ADAL" clId="{D2694319-82BD-4D14-88B9-2F36646D8A15}" dt="2024-10-15T20:56:32.208" v="57" actId="47"/>
      <pc:docMkLst>
        <pc:docMk/>
      </pc:docMkLst>
      <pc:sldChg chg="del">
        <pc:chgData name="Mohan, Man" userId="37104710-05df-4370-9d86-514a293a6e2e" providerId="ADAL" clId="{D2694319-82BD-4D14-88B9-2F36646D8A15}" dt="2024-10-11T02:52:52.129" v="0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D2694319-82BD-4D14-88B9-2F36646D8A15}" dt="2024-10-11T02:52:52.777" v="1" actId="47"/>
        <pc:sldMkLst>
          <pc:docMk/>
          <pc:sldMk cId="4205977045" sldId="257"/>
        </pc:sldMkLst>
      </pc:sldChg>
      <pc:sldChg chg="del">
        <pc:chgData name="Mohan, Man" userId="37104710-05df-4370-9d86-514a293a6e2e" providerId="ADAL" clId="{D2694319-82BD-4D14-88B9-2F36646D8A15}" dt="2024-10-11T02:52:53.355" v="2" actId="47"/>
        <pc:sldMkLst>
          <pc:docMk/>
          <pc:sldMk cId="3414948269" sldId="258"/>
        </pc:sldMkLst>
      </pc:sldChg>
      <pc:sldChg chg="del">
        <pc:chgData name="Mohan, Man" userId="37104710-05df-4370-9d86-514a293a6e2e" providerId="ADAL" clId="{D2694319-82BD-4D14-88B9-2F36646D8A15}" dt="2024-10-11T02:52:53.999" v="3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D2694319-82BD-4D14-88B9-2F36646D8A15}" dt="2024-10-11T02:52:54.532" v="4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D2694319-82BD-4D14-88B9-2F36646D8A15}" dt="2024-10-11T02:53:23.768" v="14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D2694319-82BD-4D14-88B9-2F36646D8A15}" dt="2024-10-11T02:53:26.203" v="15" actId="47"/>
        <pc:sldMkLst>
          <pc:docMk/>
          <pc:sldMk cId="2717183306" sldId="262"/>
        </pc:sldMkLst>
      </pc:sldChg>
      <pc:sldChg chg="add del">
        <pc:chgData name="Mohan, Man" userId="37104710-05df-4370-9d86-514a293a6e2e" providerId="ADAL" clId="{D2694319-82BD-4D14-88B9-2F36646D8A15}" dt="2024-10-11T02:53:43.764" v="28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D2694319-82BD-4D14-88B9-2F36646D8A15}" dt="2024-10-11T02:53:22.699" v="12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D2694319-82BD-4D14-88B9-2F36646D8A15}" dt="2024-10-11T02:53:23.233" v="13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D2694319-82BD-4D14-88B9-2F36646D8A15}" dt="2024-10-15T20:56:25.722" v="49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D2694319-82BD-4D14-88B9-2F36646D8A15}" dt="2024-10-15T20:56:26.157" v="50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D2694319-82BD-4D14-88B9-2F36646D8A15}" dt="2024-10-15T20:56:27.643" v="52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D2694319-82BD-4D14-88B9-2F36646D8A15}" dt="2024-10-15T20:56:26.474" v="51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D2694319-82BD-4D14-88B9-2F36646D8A15}" dt="2024-10-15T20:56:28.595" v="53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D2694319-82BD-4D14-88B9-2F36646D8A15}" dt="2024-10-15T20:56:29.557" v="54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D2694319-82BD-4D14-88B9-2F36646D8A15}" dt="2024-10-15T20:56:30.458" v="55" actId="47"/>
        <pc:sldMkLst>
          <pc:docMk/>
          <pc:sldMk cId="3140328593" sldId="273"/>
        </pc:sldMkLst>
      </pc:sldChg>
      <pc:sldChg chg="add del">
        <pc:chgData name="Mohan, Man" userId="37104710-05df-4370-9d86-514a293a6e2e" providerId="ADAL" clId="{D2694319-82BD-4D14-88B9-2F36646D8A15}" dt="2024-10-15T20:56:31.394" v="56" actId="47"/>
        <pc:sldMkLst>
          <pc:docMk/>
          <pc:sldMk cId="669503856" sldId="274"/>
        </pc:sldMkLst>
      </pc:sldChg>
      <pc:sldChg chg="add del">
        <pc:chgData name="Mohan, Man" userId="37104710-05df-4370-9d86-514a293a6e2e" providerId="ADAL" clId="{D2694319-82BD-4D14-88B9-2F36646D8A15}" dt="2024-10-15T20:56:32.208" v="57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D2694319-82BD-4D14-88B9-2F36646D8A15}" dt="2024-10-11T02:52:55.019" v="5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D2694319-82BD-4D14-88B9-2F36646D8A15}" dt="2024-10-11T02:52:55.992" v="6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D2694319-82BD-4D14-88B9-2F36646D8A15}" dt="2024-10-11T02:53:22.212" v="11" actId="47"/>
        <pc:sldMkLst>
          <pc:docMk/>
          <pc:sldMk cId="1149221801" sldId="288"/>
        </pc:sldMkLst>
      </pc:sldChg>
      <pc:sldChg chg="modSp add del mod">
        <pc:chgData name="Mohan, Man" userId="37104710-05df-4370-9d86-514a293a6e2e" providerId="ADAL" clId="{D2694319-82BD-4D14-88B9-2F36646D8A15}" dt="2024-10-11T02:55:12.833" v="48" actId="6549"/>
        <pc:sldMkLst>
          <pc:docMk/>
          <pc:sldMk cId="1285376761" sldId="500"/>
        </pc:sldMkLst>
        <pc:spChg chg="mod">
          <ac:chgData name="Mohan, Man" userId="37104710-05df-4370-9d86-514a293a6e2e" providerId="ADAL" clId="{D2694319-82BD-4D14-88B9-2F36646D8A15}" dt="2024-10-11T02:55:12.833" v="48" actId="6549"/>
          <ac:spMkLst>
            <pc:docMk/>
            <pc:sldMk cId="1285376761" sldId="500"/>
            <ac:spMk id="2" creationId="{A58C58D1-029F-FBCB-9981-9F87D7B30796}"/>
          </ac:spMkLst>
        </pc:spChg>
      </pc:sldChg>
      <pc:sldChg chg="del">
        <pc:chgData name="Mohan, Man" userId="37104710-05df-4370-9d86-514a293a6e2e" providerId="ADAL" clId="{D2694319-82BD-4D14-88B9-2F36646D8A15}" dt="2024-10-11T02:53:21.724" v="10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D2694319-82BD-4D14-88B9-2F36646D8A15}" dt="2024-10-11T02:53:20.358" v="9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D2694319-82BD-4D14-88B9-2F36646D8A15}" dt="2024-10-11T02:52:57.295" v="7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D2694319-82BD-4D14-88B9-2F36646D8A15}" dt="2024-10-11T02:53:18.711" v="8" actId="47"/>
        <pc:sldMkLst>
          <pc:docMk/>
          <pc:sldMk cId="2721794196" sldId="504"/>
        </pc:sldMkLst>
      </pc:sldChg>
      <pc:sldChg chg="add del">
        <pc:chgData name="Mohan, Man" userId="37104710-05df-4370-9d86-514a293a6e2e" providerId="ADAL" clId="{D2694319-82BD-4D14-88B9-2F36646D8A15}" dt="2024-10-11T02:53:40.187" v="25" actId="47"/>
        <pc:sldMkLst>
          <pc:docMk/>
          <pc:sldMk cId="4210385526" sldId="505"/>
        </pc:sldMkLst>
      </pc:sldChg>
      <pc:sldChg chg="add del">
        <pc:chgData name="Mohan, Man" userId="37104710-05df-4370-9d86-514a293a6e2e" providerId="ADAL" clId="{D2694319-82BD-4D14-88B9-2F36646D8A15}" dt="2024-10-11T02:53:41.031" v="26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7" Type="http://schemas.openxmlformats.org/officeDocument/2006/relationships/image" Target="../media/image12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7" Type="http://schemas.openxmlformats.org/officeDocument/2006/relationships/image" Target="../media/image18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6094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D  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D61E72B-A4CA-82FD-B79B-E5FC877ABC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2218" y="1747498"/>
            <a:ext cx="536448" cy="156362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06EF03B-096A-99A9-F917-B98DFE736E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1503" y="1775483"/>
            <a:ext cx="655040" cy="146049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3F58412-7C5E-8699-AF57-9DC58E005AE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4428" y="1747498"/>
            <a:ext cx="554736" cy="1459992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557B3D3-ABE0-3E16-15DA-6CCA708A0D3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702" y="1882668"/>
            <a:ext cx="573024" cy="140208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0C9E34F3-5EBF-2C41-F407-FA6B036E961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6807" y="1757700"/>
            <a:ext cx="493776" cy="147828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0D95ABC-E7D6-05C6-2E38-FF79B422ABA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636" y="1882668"/>
            <a:ext cx="591312" cy="135331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551A2654-BAB0-D672-3877-2DF82EC7D7A8}"/>
              </a:ext>
            </a:extLst>
          </p:cNvPr>
          <p:cNvSpPr txBox="1"/>
          <p:nvPr/>
        </p:nvSpPr>
        <p:spPr>
          <a:xfrm>
            <a:off x="4219775" y="3309927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647A85-D581-D46B-2FCD-6648BF5C1CE4}"/>
              </a:ext>
            </a:extLst>
          </p:cNvPr>
          <p:cNvSpPr txBox="1"/>
          <p:nvPr/>
        </p:nvSpPr>
        <p:spPr>
          <a:xfrm>
            <a:off x="1803591" y="3280675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0E6E32-DB6D-6F2B-CBBB-1453605A1F25}"/>
              </a:ext>
            </a:extLst>
          </p:cNvPr>
          <p:cNvSpPr txBox="1"/>
          <p:nvPr/>
        </p:nvSpPr>
        <p:spPr>
          <a:xfrm>
            <a:off x="3140998" y="3311121"/>
            <a:ext cx="558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FCA1E0D-06A3-4923-2723-0F6D4206018C}"/>
              </a:ext>
            </a:extLst>
          </p:cNvPr>
          <p:cNvSpPr txBox="1"/>
          <p:nvPr/>
        </p:nvSpPr>
        <p:spPr>
          <a:xfrm>
            <a:off x="575320" y="3312942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K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20A86F-7826-57A3-A9F2-B0CABF1FE9E7}"/>
              </a:ext>
            </a:extLst>
          </p:cNvPr>
          <p:cNvSpPr txBox="1"/>
          <p:nvPr/>
        </p:nvSpPr>
        <p:spPr>
          <a:xfrm>
            <a:off x="6210932" y="3311122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A1CCD00-127F-B472-E4C5-AAB2DDBF88FB}"/>
              </a:ext>
            </a:extLst>
          </p:cNvPr>
          <p:cNvSpPr txBox="1"/>
          <p:nvPr/>
        </p:nvSpPr>
        <p:spPr>
          <a:xfrm>
            <a:off x="5053425" y="3308661"/>
            <a:ext cx="1000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YRK1A</a:t>
            </a:r>
          </a:p>
        </p:txBody>
      </p:sp>
    </p:spTree>
    <p:extLst>
      <p:ext uri="{BB962C8B-B14F-4D97-AF65-F5344CB8AC3E}">
        <p14:creationId xmlns:p14="http://schemas.microsoft.com/office/powerpoint/2010/main" val="12853767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70617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D – Repeat 2 (not shown but used in calculation of 3E and 3F)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51A2654-BAB0-D672-3877-2DF82EC7D7A8}"/>
              </a:ext>
            </a:extLst>
          </p:cNvPr>
          <p:cNvSpPr txBox="1"/>
          <p:nvPr/>
        </p:nvSpPr>
        <p:spPr>
          <a:xfrm>
            <a:off x="4219775" y="3309927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647A85-D581-D46B-2FCD-6648BF5C1CE4}"/>
              </a:ext>
            </a:extLst>
          </p:cNvPr>
          <p:cNvSpPr txBox="1"/>
          <p:nvPr/>
        </p:nvSpPr>
        <p:spPr>
          <a:xfrm>
            <a:off x="1803591" y="3280675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0E6E32-DB6D-6F2B-CBBB-1453605A1F25}"/>
              </a:ext>
            </a:extLst>
          </p:cNvPr>
          <p:cNvSpPr txBox="1"/>
          <p:nvPr/>
        </p:nvSpPr>
        <p:spPr>
          <a:xfrm>
            <a:off x="3140998" y="3311121"/>
            <a:ext cx="558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FCA1E0D-06A3-4923-2723-0F6D4206018C}"/>
              </a:ext>
            </a:extLst>
          </p:cNvPr>
          <p:cNvSpPr txBox="1"/>
          <p:nvPr/>
        </p:nvSpPr>
        <p:spPr>
          <a:xfrm>
            <a:off x="575320" y="3312942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K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20A86F-7826-57A3-A9F2-B0CABF1FE9E7}"/>
              </a:ext>
            </a:extLst>
          </p:cNvPr>
          <p:cNvSpPr txBox="1"/>
          <p:nvPr/>
        </p:nvSpPr>
        <p:spPr>
          <a:xfrm>
            <a:off x="6210932" y="3311122"/>
            <a:ext cx="6880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A1CCD00-127F-B472-E4C5-AAB2DDBF88FB}"/>
              </a:ext>
            </a:extLst>
          </p:cNvPr>
          <p:cNvSpPr txBox="1"/>
          <p:nvPr/>
        </p:nvSpPr>
        <p:spPr>
          <a:xfrm>
            <a:off x="5053425" y="3308661"/>
            <a:ext cx="1000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YRK1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877168F-7E05-4D5C-983B-0B5C34B422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7803" y="1587068"/>
            <a:ext cx="585216" cy="159715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83E802F-9E34-357E-2734-FA73A246191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9144" y="1630675"/>
            <a:ext cx="573024" cy="150993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90D2713-C6DD-8BAA-C3DA-73416F5796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9868" y="1858217"/>
            <a:ext cx="576072" cy="12496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3B75C35-F608-F972-2E18-3340B147DF5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449" y="1806674"/>
            <a:ext cx="573024" cy="139598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4B62256-BE85-3DBB-9AF4-BD5541CAEB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7647" y="1715084"/>
            <a:ext cx="579120" cy="146913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B671CD5-FF18-D2AE-DA69-62F9A3D5EDB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882" y="1774856"/>
            <a:ext cx="469392" cy="1408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385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4">
            <a:extLst>
              <a:ext uri="{FF2B5EF4-FFF2-40B4-BE49-F238E27FC236}">
                <a16:creationId xmlns:a16="http://schemas.microsoft.com/office/drawing/2014/main" id="{A58C58D1-029F-FBCB-9981-9F87D7B30796}"/>
              </a:ext>
            </a:extLst>
          </p:cNvPr>
          <p:cNvSpPr txBox="1"/>
          <p:nvPr/>
        </p:nvSpPr>
        <p:spPr>
          <a:xfrm>
            <a:off x="501978" y="246584"/>
            <a:ext cx="70617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altLang="zh-CN" sz="1800" dirty="0"/>
              <a:t>Fig.3D – Repeat 3 (not shown but used in calculation of 3E and 3F)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51A2654-BAB0-D672-3877-2DF82EC7D7A8}"/>
              </a:ext>
            </a:extLst>
          </p:cNvPr>
          <p:cNvSpPr txBox="1"/>
          <p:nvPr/>
        </p:nvSpPr>
        <p:spPr>
          <a:xfrm>
            <a:off x="4219775" y="3309927"/>
            <a:ext cx="425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647A85-D581-D46B-2FCD-6648BF5C1CE4}"/>
              </a:ext>
            </a:extLst>
          </p:cNvPr>
          <p:cNvSpPr txBox="1"/>
          <p:nvPr/>
        </p:nvSpPr>
        <p:spPr>
          <a:xfrm>
            <a:off x="1803591" y="3280675"/>
            <a:ext cx="553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0E6E32-DB6D-6F2B-CBBB-1453605A1F25}"/>
              </a:ext>
            </a:extLst>
          </p:cNvPr>
          <p:cNvSpPr txBox="1"/>
          <p:nvPr/>
        </p:nvSpPr>
        <p:spPr>
          <a:xfrm>
            <a:off x="3140998" y="3311121"/>
            <a:ext cx="558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FCA1E0D-06A3-4923-2723-0F6D4206018C}"/>
              </a:ext>
            </a:extLst>
          </p:cNvPr>
          <p:cNvSpPr txBox="1"/>
          <p:nvPr/>
        </p:nvSpPr>
        <p:spPr>
          <a:xfrm>
            <a:off x="575320" y="3312942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K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120A86F-7826-57A3-A9F2-B0CABF1FE9E7}"/>
              </a:ext>
            </a:extLst>
          </p:cNvPr>
          <p:cNvSpPr txBox="1"/>
          <p:nvPr/>
        </p:nvSpPr>
        <p:spPr>
          <a:xfrm>
            <a:off x="6210932" y="3311122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A1CCD00-127F-B472-E4C5-AAB2DDBF88FB}"/>
              </a:ext>
            </a:extLst>
          </p:cNvPr>
          <p:cNvSpPr txBox="1"/>
          <p:nvPr/>
        </p:nvSpPr>
        <p:spPr>
          <a:xfrm>
            <a:off x="5053425" y="3308661"/>
            <a:ext cx="1000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YRK1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13AA893-A392-EE30-2FEE-AD42E747F6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3709" y="1865888"/>
            <a:ext cx="426720" cy="144170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00E3E9E-E344-C70B-A3CB-916C10564F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3325" y="1840354"/>
            <a:ext cx="432816" cy="14935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3376E4F-B330-F660-4058-293640E58E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944" y="1906027"/>
            <a:ext cx="505968" cy="137464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70095D5-FDF8-2908-2472-17BA1F3F6EB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9056" y="1816323"/>
            <a:ext cx="460107" cy="149126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2A8FA68-F8B0-1ADD-6EAA-5A64A257EF4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0217" y="1844346"/>
            <a:ext cx="655040" cy="137477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872CEDC-33A4-48DA-2471-5F5AA339459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9338" y="1634161"/>
            <a:ext cx="414528" cy="1584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6193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4</TotalTime>
  <Words>57</Words>
  <Application>Microsoft Office PowerPoint</Application>
  <PresentationFormat>Widescreen</PresentationFormat>
  <Paragraphs>2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56:42Z</dcterms:modified>
</cp:coreProperties>
</file>